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2"/>
    <p:sldId id="269" r:id="rId3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DD75A55F-2567-42B7-BEA1-5511FC7F8C4C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CustomShape 1"/>
          <p:cNvSpPr/>
          <p:nvPr/>
        </p:nvSpPr>
        <p:spPr>
          <a:xfrm>
            <a:off x="359640" y="8265380"/>
            <a:ext cx="2300760" cy="364680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GB" sz="1800" b="0" strike="noStrike" spc="-1">
                <a:solidFill>
                  <a:srgbClr val="000000"/>
                </a:solidFill>
                <a:latin typeface="Calibri"/>
                <a:ea typeface="Calibri"/>
              </a:rPr>
              <a:t>Supplementary Figure 2</a:t>
            </a:r>
            <a:endParaRPr lang="en-GB" sz="1800" b="0" strike="noStrike" spc="-1">
              <a:latin typeface="Arial"/>
            </a:endParaRPr>
          </a:p>
        </p:txBody>
      </p:sp>
      <p:pic>
        <p:nvPicPr>
          <p:cNvPr id="112" name="Grafik 142" descr="Grafik 142"/>
          <p:cNvPicPr/>
          <p:nvPr/>
        </p:nvPicPr>
        <p:blipFill>
          <a:blip r:embed="rId2"/>
          <a:stretch/>
        </p:blipFill>
        <p:spPr>
          <a:xfrm>
            <a:off x="325440" y="-142920"/>
            <a:ext cx="6530400" cy="9143280"/>
          </a:xfrm>
          <a:prstGeom prst="rect">
            <a:avLst/>
          </a:prstGeom>
          <a:ln w="12700">
            <a:noFill/>
          </a:ln>
        </p:spPr>
      </p:pic>
      <p:sp>
        <p:nvSpPr>
          <p:cNvPr id="113" name="CustomShape 2"/>
          <p:cNvSpPr/>
          <p:nvPr/>
        </p:nvSpPr>
        <p:spPr>
          <a:xfrm>
            <a:off x="329400" y="8823960"/>
            <a:ext cx="2149135" cy="367878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Fig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7: </a:t>
            </a:r>
            <a:endParaRPr lang="en-GB" sz="1800" b="0" strike="noStrike" spc="-1" dirty="0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p15="http://schemas.microsoft.com/office/powerpoint/2012/main">
      <p:transition spd="slow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38626" y="176462"/>
            <a:ext cx="6370721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Fig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7: Examples of semi-automated gap detection and gap measurement in each of the extracted sites of articulation.  In each image, the bottom panel shows the extracted line profile, the third panel show a pixel map of the detected air, the second panel shows an overlay of the quantified parts over the extracted line profile, and the top panel shows the measured gap width/lengths (in pixels) which are the line profiles used in the downstream analyses.</a:t>
            </a:r>
            <a:endParaRPr lang="de-DE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1250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3</Words>
  <Application>Microsoft Office PowerPoint</Application>
  <PresentationFormat>Bildschirmpräsentatio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9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3</cp:revision>
  <dcterms:modified xsi:type="dcterms:W3CDTF">2025-05-19T09:35:16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